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72" r:id="rId2"/>
    <p:sldId id="328" r:id="rId3"/>
    <p:sldId id="326" r:id="rId4"/>
    <p:sldId id="323" r:id="rId5"/>
  </p:sldIdLst>
  <p:sldSz cx="6858000" cy="9144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718" autoAdjust="0"/>
    <p:restoredTop sz="94660"/>
  </p:normalViewPr>
  <p:slideViewPr>
    <p:cSldViewPr>
      <p:cViewPr>
        <p:scale>
          <a:sx n="175" d="100"/>
          <a:sy n="175" d="100"/>
        </p:scale>
        <p:origin x="560" y="-51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119" cy="464820"/>
          </a:xfrm>
          <a:prstGeom prst="rect">
            <a:avLst/>
          </a:prstGeom>
        </p:spPr>
        <p:txBody>
          <a:bodyPr vert="horz" lIns="92433" tIns="46217" rIns="92433" bIns="46217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33" tIns="46217" rIns="92433" bIns="46217" rtlCol="0"/>
          <a:lstStyle>
            <a:lvl1pPr algn="r">
              <a:defRPr sz="1200"/>
            </a:lvl1pPr>
          </a:lstStyle>
          <a:p>
            <a:fld id="{7CF633F2-78CF-427E-8CE4-6B98443AA0DC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966"/>
            <a:ext cx="2982119" cy="464820"/>
          </a:xfrm>
          <a:prstGeom prst="rect">
            <a:avLst/>
          </a:prstGeom>
        </p:spPr>
        <p:txBody>
          <a:bodyPr vert="horz" lIns="92433" tIns="46217" rIns="92433" bIns="46217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8102" y="8829966"/>
            <a:ext cx="2982119" cy="464820"/>
          </a:xfrm>
          <a:prstGeom prst="rect">
            <a:avLst/>
          </a:prstGeom>
        </p:spPr>
        <p:txBody>
          <a:bodyPr vert="horz" lIns="92433" tIns="46217" rIns="92433" bIns="46217" rtlCol="0" anchor="b"/>
          <a:lstStyle>
            <a:lvl1pPr algn="r">
              <a:defRPr sz="1200"/>
            </a:lvl1pPr>
          </a:lstStyle>
          <a:p>
            <a:fld id="{4CA35493-3CA6-47CA-94AF-1CFD85C5F4E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93603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7F803C-C936-4358-8CE0-7CE598ED69B0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16425"/>
            <a:ext cx="55054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B73863-E1CA-422A-9012-D7D684223142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2793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B73863-E1CA-422A-9012-D7D684223142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8330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1241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5190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57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0279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6645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8191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1553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4420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7828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0576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6533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0DD62-1357-4947-AFFC-FFC200CC0A3D}" type="datetimeFigureOut">
              <a:rPr lang="en-US" smtClean="0"/>
              <a:pPr/>
              <a:t>2/10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01F9CB-BAAF-4B6F-A164-F8F01A212F14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5779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7.bin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12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6.bin"/><Relationship Id="rId5" Type="http://schemas.openxmlformats.org/officeDocument/2006/relationships/oleObject" Target="../embeddings/oleObject3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9486581"/>
              </p:ext>
            </p:extLst>
          </p:nvPr>
        </p:nvGraphicFramePr>
        <p:xfrm>
          <a:off x="228600" y="609600"/>
          <a:ext cx="6400800" cy="5930194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46853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15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07921">
                <a:tc gridSpan="2"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ary Table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│ Comprehensive Metabolic Panel in Study Participants (n=40)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53975" indent="0"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, mEq/L (133-145)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53975" indent="0" algn="l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,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Eq/L (3.1-5.1)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53975" indent="0"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loride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Eq/L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6-106)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.1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arbonate: 22-29 mmol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3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P: 8-16 mEq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cose: 70 to 100 m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4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N (blood urea nitrogen): 6 to 20 m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atinine: 0.6 to 1.3 m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0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R: &gt;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6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53975" indent="0" algn="l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,</a:t>
                      </a:r>
                      <a:r>
                        <a:rPr lang="en-US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g/dL (8.4-10.2)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protein: 6.0 to 8.3 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umin: 3.4 to 5.4 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bilirubin: 0.3 to 1.9 mg/d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aline phosphatase: 44 to 147 IU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3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7451">
                <a:tc>
                  <a:txBody>
                    <a:bodyPr/>
                    <a:lstStyle/>
                    <a:p>
                      <a:pPr marL="119063" indent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 (alanine aminotransferase): 10 to 40 IU/L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2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07921">
                <a:tc>
                  <a:txBody>
                    <a:bodyPr/>
                    <a:lstStyle/>
                    <a:p>
                      <a:pPr marL="53975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 (aspartate aminotransferase): 10 to 34 IU/L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742352">
                <a:tc grid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breviations:</a:t>
                      </a:r>
                      <a:r>
                        <a:rPr lang="en-US" sz="120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BC, white blood count; CaOx, calcium oxalate. —, not applicable.</a:t>
                      </a:r>
                    </a:p>
                    <a:p>
                      <a:pPr algn="l"/>
                      <a:endParaRPr lang="en-US" sz="400" i="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lang="en-US" sz="120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s behind parameters are normal ranges and </a:t>
                      </a:r>
                      <a:r>
                        <a:rPr lang="en-US" sz="12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e expressed as mean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</a:t>
                      </a:r>
                      <a:r>
                        <a:rPr lang="en-US" sz="12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.</a:t>
                      </a:r>
                      <a:endParaRPr lang="en-US" sz="4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60960" marB="6096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5868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5597758"/>
              </p:ext>
            </p:extLst>
          </p:nvPr>
        </p:nvGraphicFramePr>
        <p:xfrm>
          <a:off x="243840" y="457200"/>
          <a:ext cx="6561060" cy="65610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9" r:id="rId3" imgW="6878952" imgH="6877862" progId="Prism9.Document">
                  <p:embed/>
                </p:oleObj>
              </mc:Choice>
              <mc:Fallback>
                <p:oleObj name="Prism 9" r:id="rId3" imgW="6878952" imgH="687786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3840" y="457200"/>
                        <a:ext cx="6561060" cy="65610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22651" y="454025"/>
            <a:ext cx="306761" cy="322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12095" y="267738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4497" y="480060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29105" y="4540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89960" y="27094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DE0E3A9-4B74-4649-9AF3-BAB4BAEC83C6}"/>
              </a:ext>
            </a:extLst>
          </p:cNvPr>
          <p:cNvSpPr txBox="1"/>
          <p:nvPr/>
        </p:nvSpPr>
        <p:spPr>
          <a:xfrm>
            <a:off x="0" y="0"/>
            <a:ext cx="29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A83D73A-A2B9-C044-9231-3BD491660A9D}"/>
              </a:ext>
            </a:extLst>
          </p:cNvPr>
          <p:cNvSpPr/>
          <p:nvPr/>
        </p:nvSpPr>
        <p:spPr>
          <a:xfrm>
            <a:off x="228600" y="7274004"/>
            <a:ext cx="64008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nocyte cellular bioenergetics in healthy participants in response to a load (i.e. blended preparation of fruits) containing no oxalate. Individuals classified as a (A-B) decreased or (C-E) increased responders were re-recruited to consume a load containing no oxalate. Oxygen consumption rate (OCR) profile of study participants pre-load (black circles) and post-load (no oxalate) (white circles) responses. Data are from n=5 healthy participants and expressed as mean ± SE using technical replicates of 3–5 wells per group.</a:t>
            </a:r>
          </a:p>
        </p:txBody>
      </p:sp>
    </p:spTree>
    <p:extLst>
      <p:ext uri="{BB962C8B-B14F-4D97-AF65-F5344CB8AC3E}">
        <p14:creationId xmlns:p14="http://schemas.microsoft.com/office/powerpoint/2010/main" val="33966661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450" y="970404"/>
            <a:ext cx="6578591" cy="5125596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39B55152-F0C8-224A-B90B-EEC55223C5C9}"/>
              </a:ext>
            </a:extLst>
          </p:cNvPr>
          <p:cNvGrpSpPr/>
          <p:nvPr/>
        </p:nvGrpSpPr>
        <p:grpSpPr>
          <a:xfrm>
            <a:off x="57407" y="685800"/>
            <a:ext cx="463439" cy="2853154"/>
            <a:chOff x="57407" y="685800"/>
            <a:chExt cx="463439" cy="2853154"/>
          </a:xfrm>
        </p:grpSpPr>
        <p:sp>
          <p:nvSpPr>
            <p:cNvPr id="14" name="TextBox 13"/>
            <p:cNvSpPr txBox="1"/>
            <p:nvPr/>
          </p:nvSpPr>
          <p:spPr>
            <a:xfrm>
              <a:off x="57407" y="685800"/>
              <a:ext cx="4634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407" y="3200400"/>
              <a:ext cx="4634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E67272C-B14B-6C43-AEC1-7E7329E6B966}"/>
              </a:ext>
            </a:extLst>
          </p:cNvPr>
          <p:cNvSpPr txBox="1"/>
          <p:nvPr/>
        </p:nvSpPr>
        <p:spPr>
          <a:xfrm>
            <a:off x="0" y="0"/>
            <a:ext cx="29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169F67A-1F1A-BC47-A847-00B5004A367B}"/>
              </a:ext>
            </a:extLst>
          </p:cNvPr>
          <p:cNvSpPr/>
          <p:nvPr/>
        </p:nvSpPr>
        <p:spPr>
          <a:xfrm>
            <a:off x="228600" y="6553200"/>
            <a:ext cx="64008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onocyte cellular bioenergetics in healthy participants in response to an oxalate load on different days. Representative oxygen consumption rate (OCR) profiles of (A) decreased and (B) increased responders' pre-oxalate (black circles) and post-oxalate responses (white circles) on two different days. Data are from n=10 healthy participants and expressed as mean ± SE using technical replicates of 3–5 wells per group.</a:t>
            </a:r>
          </a:p>
        </p:txBody>
      </p:sp>
    </p:spTree>
    <p:extLst>
      <p:ext uri="{BB962C8B-B14F-4D97-AF65-F5344CB8AC3E}">
        <p14:creationId xmlns:p14="http://schemas.microsoft.com/office/powerpoint/2010/main" val="40989622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268157" y="454025"/>
            <a:ext cx="3291840" cy="2468880"/>
            <a:chOff x="-59003" y="0"/>
            <a:chExt cx="3564203" cy="2590800"/>
          </a:xfrm>
        </p:grpSpPr>
        <p:sp>
          <p:nvSpPr>
            <p:cNvPr id="8" name="TextBox 7"/>
            <p:cNvSpPr txBox="1"/>
            <p:nvPr/>
          </p:nvSpPr>
          <p:spPr>
            <a:xfrm>
              <a:off x="0" y="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23" name="Object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686923"/>
                </p:ext>
              </p:extLst>
            </p:nvPr>
          </p:nvGraphicFramePr>
          <p:xfrm>
            <a:off x="-59003" y="30480"/>
            <a:ext cx="3564203" cy="25603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6" name="Prism 9" r:id="rId3" imgW="4024877" imgH="2890596" progId="Prism9.Document">
                    <p:embed/>
                  </p:oleObj>
                </mc:Choice>
                <mc:Fallback>
                  <p:oleObj name="Prism 9" r:id="rId3" imgW="4024877" imgH="2890596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59003" y="30480"/>
                          <a:ext cx="3564203" cy="25603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6" name="Group 25"/>
          <p:cNvGrpSpPr/>
          <p:nvPr/>
        </p:nvGrpSpPr>
        <p:grpSpPr>
          <a:xfrm>
            <a:off x="268157" y="3139440"/>
            <a:ext cx="3291840" cy="2468880"/>
            <a:chOff x="-59003" y="2667000"/>
            <a:chExt cx="3564203" cy="2590800"/>
          </a:xfrm>
        </p:grpSpPr>
        <p:sp>
          <p:nvSpPr>
            <p:cNvPr id="10" name="TextBox 9"/>
            <p:cNvSpPr txBox="1"/>
            <p:nvPr/>
          </p:nvSpPr>
          <p:spPr>
            <a:xfrm>
              <a:off x="-11430" y="266700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25" name="Objec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07650467"/>
                </p:ext>
              </p:extLst>
            </p:nvPr>
          </p:nvGraphicFramePr>
          <p:xfrm>
            <a:off x="-59003" y="2697480"/>
            <a:ext cx="3564203" cy="25603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7" name="Prism 9" r:id="rId5" imgW="4024877" imgH="2890596" progId="Prism9.Document">
                    <p:embed/>
                  </p:oleObj>
                </mc:Choice>
                <mc:Fallback>
                  <p:oleObj name="Prism 9" r:id="rId5" imgW="4024877" imgH="2890596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-59003" y="2697480"/>
                          <a:ext cx="3564203" cy="25603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8" name="Group 27"/>
          <p:cNvGrpSpPr/>
          <p:nvPr/>
        </p:nvGrpSpPr>
        <p:grpSpPr>
          <a:xfrm>
            <a:off x="289560" y="5669280"/>
            <a:ext cx="3291840" cy="2468880"/>
            <a:chOff x="-37600" y="5364480"/>
            <a:chExt cx="3542800" cy="2560320"/>
          </a:xfrm>
        </p:grpSpPr>
        <p:sp>
          <p:nvSpPr>
            <p:cNvPr id="12" name="TextBox 11"/>
            <p:cNvSpPr txBox="1"/>
            <p:nvPr/>
          </p:nvSpPr>
          <p:spPr>
            <a:xfrm>
              <a:off x="0" y="537754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27" name="Object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6552548"/>
                </p:ext>
              </p:extLst>
            </p:nvPr>
          </p:nvGraphicFramePr>
          <p:xfrm>
            <a:off x="-37600" y="5364480"/>
            <a:ext cx="3542800" cy="25603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8" name="Prism 9" r:id="rId7" imgW="4024877" imgH="2908964" progId="Prism9.Document">
                    <p:embed/>
                  </p:oleObj>
                </mc:Choice>
                <mc:Fallback>
                  <p:oleObj name="Prism 9" r:id="rId7" imgW="4024877" imgH="2908964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-37600" y="5364480"/>
                          <a:ext cx="3542800" cy="25603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0" name="Group 29"/>
          <p:cNvGrpSpPr/>
          <p:nvPr/>
        </p:nvGrpSpPr>
        <p:grpSpPr>
          <a:xfrm>
            <a:off x="3429105" y="433388"/>
            <a:ext cx="3292370" cy="2538412"/>
            <a:chOff x="3642962" y="-21656"/>
            <a:chExt cx="3520405" cy="2663766"/>
          </a:xfrm>
        </p:grpSpPr>
        <p:sp>
          <p:nvSpPr>
            <p:cNvPr id="14" name="TextBox 13"/>
            <p:cNvSpPr txBox="1"/>
            <p:nvPr/>
          </p:nvSpPr>
          <p:spPr>
            <a:xfrm>
              <a:off x="3642962" y="0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aphicFrame>
          <p:nvGraphicFramePr>
            <p:cNvPr id="29" name="Object 2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6179452"/>
                </p:ext>
              </p:extLst>
            </p:nvPr>
          </p:nvGraphicFramePr>
          <p:xfrm>
            <a:off x="3668312" y="-21656"/>
            <a:ext cx="3495055" cy="26637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09" name="Prism 9" r:id="rId9" imgW="3970136" imgH="3024934" progId="Prism9.Document">
                    <p:embed/>
                  </p:oleObj>
                </mc:Choice>
                <mc:Fallback>
                  <p:oleObj name="Prism 9" r:id="rId9" imgW="3970136" imgH="3024934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668312" y="-21656"/>
                          <a:ext cx="3495055" cy="266376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4" name="Group 33"/>
          <p:cNvGrpSpPr/>
          <p:nvPr/>
        </p:nvGrpSpPr>
        <p:grpSpPr>
          <a:xfrm>
            <a:off x="3489960" y="3169920"/>
            <a:ext cx="3291840" cy="2468880"/>
            <a:chOff x="3703817" y="2697480"/>
            <a:chExt cx="3458983" cy="2560320"/>
          </a:xfrm>
        </p:grpSpPr>
        <p:sp>
          <p:nvSpPr>
            <p:cNvPr id="16" name="TextBox 15"/>
            <p:cNvSpPr txBox="1"/>
            <p:nvPr/>
          </p:nvSpPr>
          <p:spPr>
            <a:xfrm>
              <a:off x="3703817" y="2699117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aphicFrame>
          <p:nvGraphicFramePr>
            <p:cNvPr id="33" name="Object 3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785492"/>
                </p:ext>
              </p:extLst>
            </p:nvPr>
          </p:nvGraphicFramePr>
          <p:xfrm>
            <a:off x="3724815" y="2697480"/>
            <a:ext cx="3437985" cy="25603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10" name="Prism 9" r:id="rId11" imgW="3906032" imgH="2908964" progId="Prism9.Document">
                    <p:embed/>
                  </p:oleObj>
                </mc:Choice>
                <mc:Fallback>
                  <p:oleObj name="Prism 9" r:id="rId11" imgW="3906032" imgH="2908964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724815" y="2697480"/>
                          <a:ext cx="3437985" cy="25603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6" name="Group 35"/>
          <p:cNvGrpSpPr/>
          <p:nvPr/>
        </p:nvGrpSpPr>
        <p:grpSpPr>
          <a:xfrm>
            <a:off x="3489960" y="5669280"/>
            <a:ext cx="3291840" cy="2468880"/>
            <a:chOff x="3703817" y="5364480"/>
            <a:chExt cx="3458983" cy="2560320"/>
          </a:xfrm>
        </p:grpSpPr>
        <p:sp>
          <p:nvSpPr>
            <p:cNvPr id="18" name="TextBox 17"/>
            <p:cNvSpPr txBox="1"/>
            <p:nvPr/>
          </p:nvSpPr>
          <p:spPr>
            <a:xfrm>
              <a:off x="3703817" y="5398234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aphicFrame>
          <p:nvGraphicFramePr>
            <p:cNvPr id="35" name="Object 3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6966198"/>
                </p:ext>
              </p:extLst>
            </p:nvPr>
          </p:nvGraphicFramePr>
          <p:xfrm>
            <a:off x="3724815" y="5364480"/>
            <a:ext cx="3437985" cy="25603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511" name="Prism 9" r:id="rId13" imgW="3906032" imgH="2908964" progId="Prism9.Document">
                    <p:embed/>
                  </p:oleObj>
                </mc:Choice>
                <mc:Fallback>
                  <p:oleObj name="Prism 9" r:id="rId13" imgW="3906032" imgH="2908964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724815" y="5364480"/>
                          <a:ext cx="3437985" cy="25603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ADE0E3A9-4B74-4649-9AF3-BAB4BAEC83C6}"/>
              </a:ext>
            </a:extLst>
          </p:cNvPr>
          <p:cNvSpPr txBox="1"/>
          <p:nvPr/>
        </p:nvSpPr>
        <p:spPr>
          <a:xfrm>
            <a:off x="0" y="0"/>
            <a:ext cx="29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A83D73A-A2B9-C044-9231-3BD491660A9D}"/>
              </a:ext>
            </a:extLst>
          </p:cNvPr>
          <p:cNvSpPr/>
          <p:nvPr/>
        </p:nvSpPr>
        <p:spPr>
          <a:xfrm>
            <a:off x="228600" y="8153400"/>
            <a:ext cx="6400800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Urinary oxalate levels in healthy participants based on their monocyte cellular bioenergetic responses. (A, B, C) Soluble oxalate and (D, E, F) crystalline oxalate levels in pre-oxalate (black circles) and post-oxalate (white circles) urine samples. Data are from n=13 (decreased), n=8 (same), n=12 (increased) healthy participants. Data was analyzed using paired t-test.</a:t>
            </a:r>
          </a:p>
        </p:txBody>
      </p:sp>
    </p:spTree>
    <p:extLst>
      <p:ext uri="{BB962C8B-B14F-4D97-AF65-F5344CB8AC3E}">
        <p14:creationId xmlns:p14="http://schemas.microsoft.com/office/powerpoint/2010/main" val="904699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098</TotalTime>
  <Words>516</Words>
  <Application>Microsoft Macintosh PowerPoint</Application>
  <PresentationFormat>On-screen Show (4:3)</PresentationFormat>
  <Paragraphs>56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>UAB Dept of Path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ecia Mitchell</dc:creator>
  <cp:lastModifiedBy>Mitchell, Tanecia (Campus)</cp:lastModifiedBy>
  <cp:revision>552</cp:revision>
  <cp:lastPrinted>2020-09-14T21:25:38Z</cp:lastPrinted>
  <dcterms:created xsi:type="dcterms:W3CDTF">2014-06-17T19:07:43Z</dcterms:created>
  <dcterms:modified xsi:type="dcterms:W3CDTF">2021-02-10T23:06:04Z</dcterms:modified>
</cp:coreProperties>
</file>